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9472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59" d="100"/>
          <a:sy n="59" d="100"/>
        </p:scale>
        <p:origin x="26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B50067F-A777-0A50-B12A-766B0F8809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85264F2B-07B0-9E43-CF90-CF92234E1A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80C812E0-9B98-F076-204B-5E194583A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2A8266D-98AE-1503-C94A-7C0422462D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6FE5601D-14C8-368E-AC64-C6BBD52CF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6621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F3AC7EF-E1B7-B964-4F60-1491303749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75AF7205-52D9-F6E7-7A10-6D7070CC6E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0B797D0F-DFBF-73F9-B338-53799C5F2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4D6F7F2A-2161-8F6E-FC39-1A4CBB598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C2DED6FE-1C71-E058-B686-6D2105363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7196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C72181F4-38F9-70E3-417A-D81A8691D9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BBD9D4D1-11CB-173A-ED78-8F63ABFC47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622B0AC-09DD-6462-AE8E-73527B0DB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86110738-A100-01F2-ED62-0574D3932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D7A1214-9F0A-4D43-5743-F3E74D8B7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1702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31229C0-D533-3C0D-4A0B-4D542618F1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2A7555D-86B6-F1AA-45AD-8758F87DFA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BEB920F3-0CE3-BF11-D8E0-B1FD7F2F5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02260D9-4067-46A3-2290-0803ED8B5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28E5470B-A44C-063E-17F5-2B5B43AE6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026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88D85F4-EAF7-9722-C1F9-60F87DB731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C55CDD07-3324-DB49-4569-3F2E9ECDD0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644730F5-9D02-29D0-46CD-FE67E6A64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0F5ACCA6-5BC8-29C7-174B-EE8B5D200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DA8A061E-C0F3-2F28-169A-CA6FBBA96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8595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0082ED1-ACA4-2058-EE06-97C9BE4EE3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D8CF1D6C-AC27-25CD-F260-5D1E88766E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7C6A3E97-1763-108B-DA1C-7914BC2C64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1389ADBB-553F-1829-D54A-84493049FB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ADB6C00D-1370-0965-8827-6C8E164AC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678C2272-AAB4-90AA-4FC4-11B22934DB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800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202BADE-B0CD-95A4-D4D4-53624D2719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B2E05F44-E430-FB1C-82EA-4592E80C40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AFFF6DAA-56C2-0AD9-B898-B0F5999CF6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78E4BD05-714D-0371-61E2-5E6AD80EC6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B11E195F-7721-2D9A-CFDB-C4E947E528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03828C77-B273-BA8F-2D1C-246744E11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E5A25D56-E41B-A453-E871-2762BF3E0B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1C95EBA5-F378-BD02-2AF8-2D768232C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910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79964021-250B-35B0-3D96-21EFEF8613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990B67E1-472B-59F6-DF5C-82A7BC8F8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9F8298A4-F5E2-70BE-1342-DF9D77F6D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88196B6C-ECC4-2ECB-3E00-F7E6269DF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6613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DF0D855A-DF9E-1393-B089-4D9D6FE1E0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8FE1B2FB-3FCA-7ADE-2F91-FCC4688AA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FB3A3ED9-B1BD-3C7E-ED13-94F3D122B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8398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0E3EB8D-7956-8C80-8497-018D5E5411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61683A55-A27B-724A-C0C3-1602A38261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923F6906-8B96-F299-A746-F856E99ED9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C8C87300-602F-FCA8-D41F-CB2BE1ABB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792DFE1C-FD33-DFD8-6015-3A3BCE3B4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8D81B4A0-848B-52CB-22AF-D7B2C91A9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2264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0B1F469-9F8E-62BC-4786-10102A083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4FF1C821-326D-FB0E-735B-3A0BAD3621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1C83BE02-3498-B0D9-78A7-448763CA81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41865124-1A54-D649-ADE6-D920ECA70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26CF0D11-687F-F95D-43AF-68B35FD2E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F2E411D3-C417-FB2B-1458-A06A82841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465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246B6598-BDB8-8E8C-466B-27142355A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GB"/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19095A3E-4149-5A42-4792-4318AB3383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GB"/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1E42A2A2-9E71-E99E-1CEB-7EB1A7A74D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39E4A7-B968-4AED-B83D-C93B4846FF6D}" type="datetimeFigureOut">
              <a:rPr lang="en-GB" smtClean="0"/>
              <a:t>19/06/2024</a:t>
            </a:fld>
            <a:endParaRPr lang="en-GB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9E5C07E-C1D6-AA99-5884-6773E1BB09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B45B943-DC6A-A2F9-33D5-AAB04CF9F78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6420BA3-9847-4FE6-8BD5-6EA42255BDF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8747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ruta 5">
            <a:extLst>
              <a:ext uri="{FF2B5EF4-FFF2-40B4-BE49-F238E27FC236}">
                <a16:creationId xmlns:a16="http://schemas.microsoft.com/office/drawing/2014/main" id="{8661892D-2D51-3043-2C97-37ED7E543BA3}"/>
              </a:ext>
            </a:extLst>
          </p:cNvPr>
          <p:cNvSpPr txBox="1"/>
          <p:nvPr/>
        </p:nvSpPr>
        <p:spPr>
          <a:xfrm>
            <a:off x="3587262" y="1504472"/>
            <a:ext cx="4302369" cy="8527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Randomized: n=100</a:t>
            </a:r>
          </a:p>
        </p:txBody>
      </p:sp>
      <p:sp>
        <p:nvSpPr>
          <p:cNvPr id="12" name="textruta 11">
            <a:extLst>
              <a:ext uri="{FF2B5EF4-FFF2-40B4-BE49-F238E27FC236}">
                <a16:creationId xmlns:a16="http://schemas.microsoft.com/office/drawing/2014/main" id="{B8A0AF34-33E0-A213-BB5C-1A27662EB37D}"/>
              </a:ext>
            </a:extLst>
          </p:cNvPr>
          <p:cNvSpPr txBox="1"/>
          <p:nvPr/>
        </p:nvSpPr>
        <p:spPr>
          <a:xfrm>
            <a:off x="1792012" y="577543"/>
            <a:ext cx="3581926" cy="5675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Population-based cohort: n=65</a:t>
            </a:r>
          </a:p>
        </p:txBody>
      </p:sp>
      <p:sp>
        <p:nvSpPr>
          <p:cNvPr id="13" name="textruta 12">
            <a:extLst>
              <a:ext uri="{FF2B5EF4-FFF2-40B4-BE49-F238E27FC236}">
                <a16:creationId xmlns:a16="http://schemas.microsoft.com/office/drawing/2014/main" id="{0569257D-4582-3593-0A03-BA1B2A5336B8}"/>
              </a:ext>
            </a:extLst>
          </p:cNvPr>
          <p:cNvSpPr txBox="1"/>
          <p:nvPr/>
        </p:nvSpPr>
        <p:spPr>
          <a:xfrm>
            <a:off x="6095030" y="577542"/>
            <a:ext cx="3581926" cy="56755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New recruits: n=35</a:t>
            </a:r>
          </a:p>
        </p:txBody>
      </p:sp>
      <p:sp>
        <p:nvSpPr>
          <p:cNvPr id="14" name="textruta 13">
            <a:extLst>
              <a:ext uri="{FF2B5EF4-FFF2-40B4-BE49-F238E27FC236}">
                <a16:creationId xmlns:a16="http://schemas.microsoft.com/office/drawing/2014/main" id="{AE0F7232-0574-82B1-2E25-FD9B4137CDAC}"/>
              </a:ext>
            </a:extLst>
          </p:cNvPr>
          <p:cNvSpPr txBox="1"/>
          <p:nvPr/>
        </p:nvSpPr>
        <p:spPr>
          <a:xfrm>
            <a:off x="1792012" y="2705073"/>
            <a:ext cx="3581926" cy="103959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Allocated to intervention: n=50</a:t>
            </a:r>
            <a:endParaRPr lang="en-GB" sz="16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/>
              <a:t>Population based: n=34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/>
              <a:t>New recruits: n=16</a:t>
            </a:r>
          </a:p>
        </p:txBody>
      </p:sp>
      <p:sp>
        <p:nvSpPr>
          <p:cNvPr id="15" name="textruta 14">
            <a:extLst>
              <a:ext uri="{FF2B5EF4-FFF2-40B4-BE49-F238E27FC236}">
                <a16:creationId xmlns:a16="http://schemas.microsoft.com/office/drawing/2014/main" id="{CB119CAA-1C46-2579-7A92-88F974BD0DC0}"/>
              </a:ext>
            </a:extLst>
          </p:cNvPr>
          <p:cNvSpPr txBox="1"/>
          <p:nvPr/>
        </p:nvSpPr>
        <p:spPr>
          <a:xfrm>
            <a:off x="1792012" y="4163672"/>
            <a:ext cx="3581926" cy="103959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endParaRPr lang="en-GB" dirty="0"/>
          </a:p>
          <a:p>
            <a:pPr algn="ctr"/>
            <a:r>
              <a:rPr lang="en-GB" dirty="0"/>
              <a:t>Lost to follow up: n=2</a:t>
            </a:r>
            <a:endParaRPr lang="en-GB" sz="1600" dirty="0"/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Deceased: n=0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Discontinued: n=2</a:t>
            </a:r>
            <a:endParaRPr lang="en-GB" dirty="0"/>
          </a:p>
          <a:p>
            <a:pPr algn="ctr"/>
            <a:endParaRPr lang="en-GB" dirty="0"/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16864C88-4626-019C-2A49-37BE830BC539}"/>
              </a:ext>
            </a:extLst>
          </p:cNvPr>
          <p:cNvSpPr txBox="1"/>
          <p:nvPr/>
        </p:nvSpPr>
        <p:spPr>
          <a:xfrm>
            <a:off x="1792012" y="5562637"/>
            <a:ext cx="3581926" cy="10367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Analysed: n=48</a:t>
            </a:r>
            <a:endParaRPr lang="en-GB" sz="1600" dirty="0"/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GMFM: n=48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PEDI: n</a:t>
            </a:r>
            <a:r>
              <a:rPr lang="en-GB" sz="1600"/>
              <a:t>=47</a:t>
            </a:r>
            <a:endParaRPr lang="en-GB" sz="1600" dirty="0"/>
          </a:p>
        </p:txBody>
      </p:sp>
      <p:sp>
        <p:nvSpPr>
          <p:cNvPr id="17" name="textruta 16">
            <a:extLst>
              <a:ext uri="{FF2B5EF4-FFF2-40B4-BE49-F238E27FC236}">
                <a16:creationId xmlns:a16="http://schemas.microsoft.com/office/drawing/2014/main" id="{CDA694F1-C0FF-7B0F-BAB9-B964CA17F32B}"/>
              </a:ext>
            </a:extLst>
          </p:cNvPr>
          <p:cNvSpPr txBox="1"/>
          <p:nvPr/>
        </p:nvSpPr>
        <p:spPr>
          <a:xfrm>
            <a:off x="6103356" y="2706212"/>
            <a:ext cx="3581926" cy="10384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Allocated to waiting list: n=50</a:t>
            </a:r>
            <a:endParaRPr lang="en-GB" sz="1600" dirty="0"/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/>
              <a:t>Population based: n=31</a:t>
            </a:r>
          </a:p>
          <a:p>
            <a:pPr marL="742950" lvl="1" indent="-285750">
              <a:buFont typeface="Arial" panose="020B0604020202020204" pitchFamily="34" charset="0"/>
              <a:buChar char="•"/>
            </a:pPr>
            <a:r>
              <a:rPr lang="en-GB" sz="1600" dirty="0"/>
              <a:t>New recruits: </a:t>
            </a:r>
            <a:r>
              <a:rPr lang="en-GB" sz="1600"/>
              <a:t>n=19</a:t>
            </a:r>
            <a:endParaRPr lang="en-GB" sz="1600" dirty="0"/>
          </a:p>
        </p:txBody>
      </p:sp>
      <p:sp>
        <p:nvSpPr>
          <p:cNvPr id="18" name="textruta 17">
            <a:extLst>
              <a:ext uri="{FF2B5EF4-FFF2-40B4-BE49-F238E27FC236}">
                <a16:creationId xmlns:a16="http://schemas.microsoft.com/office/drawing/2014/main" id="{17052185-DAAF-B03D-7CBF-328B977C41F8}"/>
              </a:ext>
            </a:extLst>
          </p:cNvPr>
          <p:cNvSpPr txBox="1"/>
          <p:nvPr/>
        </p:nvSpPr>
        <p:spPr>
          <a:xfrm>
            <a:off x="6096000" y="4163671"/>
            <a:ext cx="3581926" cy="10384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Lost to follow up: n=4</a:t>
            </a:r>
            <a:endParaRPr lang="en-GB" sz="1600" dirty="0"/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Deceased: n=3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Discontinued: n=1</a:t>
            </a:r>
          </a:p>
        </p:txBody>
      </p:sp>
      <p:sp>
        <p:nvSpPr>
          <p:cNvPr id="19" name="textruta 18">
            <a:extLst>
              <a:ext uri="{FF2B5EF4-FFF2-40B4-BE49-F238E27FC236}">
                <a16:creationId xmlns:a16="http://schemas.microsoft.com/office/drawing/2014/main" id="{9DA4CBED-2705-B889-0E57-5D69B84B1049}"/>
              </a:ext>
            </a:extLst>
          </p:cNvPr>
          <p:cNvSpPr txBox="1"/>
          <p:nvPr/>
        </p:nvSpPr>
        <p:spPr>
          <a:xfrm>
            <a:off x="6103356" y="5565529"/>
            <a:ext cx="3581926" cy="103670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 anchorCtr="0">
            <a:noAutofit/>
          </a:bodyPr>
          <a:lstStyle/>
          <a:p>
            <a:pPr algn="ctr"/>
            <a:r>
              <a:rPr lang="en-GB" dirty="0"/>
              <a:t>Analysed n=46</a:t>
            </a:r>
            <a:endParaRPr lang="en-GB" sz="1600" dirty="0"/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GMFM: n= 46</a:t>
            </a: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GB" sz="1600" dirty="0"/>
              <a:t>PEDI: n=46</a:t>
            </a:r>
          </a:p>
        </p:txBody>
      </p:sp>
      <p:cxnSp>
        <p:nvCxnSpPr>
          <p:cNvPr id="22" name="Koppling: vinklad 21">
            <a:extLst>
              <a:ext uri="{FF2B5EF4-FFF2-40B4-BE49-F238E27FC236}">
                <a16:creationId xmlns:a16="http://schemas.microsoft.com/office/drawing/2014/main" id="{D87D9143-8ADB-C6E4-7842-2EC6F612306E}"/>
              </a:ext>
            </a:extLst>
          </p:cNvPr>
          <p:cNvCxnSpPr>
            <a:cxnSpLocks/>
          </p:cNvCxnSpPr>
          <p:nvPr/>
        </p:nvCxnSpPr>
        <p:spPr>
          <a:xfrm rot="16200000" flipH="1">
            <a:off x="4620930" y="1181335"/>
            <a:ext cx="359370" cy="286901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Koppling: vinklad 24">
            <a:extLst>
              <a:ext uri="{FF2B5EF4-FFF2-40B4-BE49-F238E27FC236}">
                <a16:creationId xmlns:a16="http://schemas.microsoft.com/office/drawing/2014/main" id="{C7AADE83-EEC5-3A75-1139-2CDC1ADAF370}"/>
              </a:ext>
            </a:extLst>
          </p:cNvPr>
          <p:cNvCxnSpPr>
            <a:cxnSpLocks/>
          </p:cNvCxnSpPr>
          <p:nvPr/>
        </p:nvCxnSpPr>
        <p:spPr>
          <a:xfrm rot="5400000">
            <a:off x="6481004" y="1173711"/>
            <a:ext cx="376682" cy="284842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Koppling: vinklad 40">
            <a:extLst>
              <a:ext uri="{FF2B5EF4-FFF2-40B4-BE49-F238E27FC236}">
                <a16:creationId xmlns:a16="http://schemas.microsoft.com/office/drawing/2014/main" id="{1948B07D-63A6-3407-1548-1B0F48AF9211}"/>
              </a:ext>
            </a:extLst>
          </p:cNvPr>
          <p:cNvCxnSpPr>
            <a:cxnSpLocks/>
          </p:cNvCxnSpPr>
          <p:nvPr/>
        </p:nvCxnSpPr>
        <p:spPr>
          <a:xfrm rot="16200000" flipH="1">
            <a:off x="4479803" y="2523064"/>
            <a:ext cx="354726" cy="3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Koppling: vinklad 42">
            <a:extLst>
              <a:ext uri="{FF2B5EF4-FFF2-40B4-BE49-F238E27FC236}">
                <a16:creationId xmlns:a16="http://schemas.microsoft.com/office/drawing/2014/main" id="{90CBFE49-5E34-A657-C53D-B23ACD628646}"/>
              </a:ext>
            </a:extLst>
          </p:cNvPr>
          <p:cNvCxnSpPr>
            <a:cxnSpLocks/>
          </p:cNvCxnSpPr>
          <p:nvPr/>
        </p:nvCxnSpPr>
        <p:spPr>
          <a:xfrm rot="16200000" flipH="1">
            <a:off x="6640708" y="2535734"/>
            <a:ext cx="354726" cy="3"/>
          </a:xfrm>
          <a:prstGeom prst="bentConnector3">
            <a:avLst>
              <a:gd name="adj1" fmla="val 94444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Koppling: vinklad 44">
            <a:extLst>
              <a:ext uri="{FF2B5EF4-FFF2-40B4-BE49-F238E27FC236}">
                <a16:creationId xmlns:a16="http://schemas.microsoft.com/office/drawing/2014/main" id="{67E9FB09-7792-6845-E4F3-3425D86C0C79}"/>
              </a:ext>
            </a:extLst>
          </p:cNvPr>
          <p:cNvCxnSpPr>
            <a:cxnSpLocks/>
          </p:cNvCxnSpPr>
          <p:nvPr/>
        </p:nvCxnSpPr>
        <p:spPr>
          <a:xfrm rot="16200000" flipH="1">
            <a:off x="4444203" y="3950709"/>
            <a:ext cx="425923" cy="3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Koppling: vinklad 46">
            <a:extLst>
              <a:ext uri="{FF2B5EF4-FFF2-40B4-BE49-F238E27FC236}">
                <a16:creationId xmlns:a16="http://schemas.microsoft.com/office/drawing/2014/main" id="{9C2EAC94-1E7E-5AAB-527E-68CF12A52D1E}"/>
              </a:ext>
            </a:extLst>
          </p:cNvPr>
          <p:cNvCxnSpPr>
            <a:cxnSpLocks/>
          </p:cNvCxnSpPr>
          <p:nvPr/>
        </p:nvCxnSpPr>
        <p:spPr>
          <a:xfrm rot="16200000" flipH="1">
            <a:off x="6594088" y="3965164"/>
            <a:ext cx="425923" cy="3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Koppling: vinklad 47">
            <a:extLst>
              <a:ext uri="{FF2B5EF4-FFF2-40B4-BE49-F238E27FC236}">
                <a16:creationId xmlns:a16="http://schemas.microsoft.com/office/drawing/2014/main" id="{942868F5-5B37-AA44-03F0-3572DA7FD98F}"/>
              </a:ext>
            </a:extLst>
          </p:cNvPr>
          <p:cNvCxnSpPr>
            <a:cxnSpLocks/>
          </p:cNvCxnSpPr>
          <p:nvPr/>
        </p:nvCxnSpPr>
        <p:spPr>
          <a:xfrm rot="16200000" flipH="1">
            <a:off x="4477477" y="5382950"/>
            <a:ext cx="359371" cy="1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Koppling: vinklad 49">
            <a:extLst>
              <a:ext uri="{FF2B5EF4-FFF2-40B4-BE49-F238E27FC236}">
                <a16:creationId xmlns:a16="http://schemas.microsoft.com/office/drawing/2014/main" id="{37B8A98C-B064-13B7-409B-B06EA2783CE4}"/>
              </a:ext>
            </a:extLst>
          </p:cNvPr>
          <p:cNvCxnSpPr>
            <a:cxnSpLocks/>
          </p:cNvCxnSpPr>
          <p:nvPr/>
        </p:nvCxnSpPr>
        <p:spPr>
          <a:xfrm rot="16200000" flipH="1">
            <a:off x="6633664" y="5382950"/>
            <a:ext cx="359371" cy="1"/>
          </a:xfrm>
          <a:prstGeom prst="bentConnector3">
            <a:avLst>
              <a:gd name="adj1" fmla="val 50000"/>
            </a:avLst>
          </a:prstGeom>
          <a:ln w="28575"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98796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</TotalTime>
  <Words>121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-t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Hans Forssberg</dc:creator>
  <cp:lastModifiedBy>Hans Forssberg</cp:lastModifiedBy>
  <cp:revision>12</cp:revision>
  <cp:lastPrinted>2024-03-06T13:06:42Z</cp:lastPrinted>
  <dcterms:created xsi:type="dcterms:W3CDTF">2024-03-06T12:53:23Z</dcterms:created>
  <dcterms:modified xsi:type="dcterms:W3CDTF">2024-06-19T11:21:15Z</dcterms:modified>
</cp:coreProperties>
</file>